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25" autoAdjust="0"/>
    <p:restoredTop sz="96866" autoAdjust="0"/>
  </p:normalViewPr>
  <p:slideViewPr>
    <p:cSldViewPr snapToGrid="0">
      <p:cViewPr varScale="1">
        <p:scale>
          <a:sx n="87" d="100"/>
          <a:sy n="87" d="100"/>
        </p:scale>
        <p:origin x="63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3DD6BB0-6389-0BF1-409F-11D3CC6EF2A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6D21DCBC-C2EA-4B82-AC10-3CE6A85D86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9226092-F8D3-E027-3161-ED3ECC9505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209D4FF-6FA5-DA12-455C-E40EC1DA74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2D30AF8-4332-5EC9-6AF6-CCC85A5C5C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64229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BB24B98-D481-3292-2061-427A3F5004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D2BB4D66-90D5-E897-5D47-756456453B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9837A8F-3E61-4246-9AB7-D7775C51EF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12F1D2E-ADD4-CC67-9823-FD95C262A5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33E1BEC-F5AB-6AA7-24B1-5F21EC085E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43837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57CF252E-95BC-DF88-1423-FB7BDE0418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1AD8475-4929-CDF6-5BC3-4760BBCFEA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C2737A6-23E3-51E3-FBBF-E2FF99392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40C1A60-95FB-3FD7-94DF-261B82951E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CEEEB27-8B29-A3EC-734C-81F7E28035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93270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59DB611-F80D-C2E6-9266-E8BAB9CDA9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A216998-6A5F-1AD2-B2AF-74E4B06A73D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D0B6A55-AE0F-CCD8-D2C3-C80ACC3A5F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F4613EB-1838-0851-6776-74A059448F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306F2EF-D5B1-9DEF-7141-F5A950C65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6499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1B6DEA4-F15E-5D23-B751-1949595B31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1441237-32FF-E7A0-DB28-6C78CACFE8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FF1F580-D813-EA75-146A-5E819564D6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AACDA32-7592-111F-0F02-8D29C3248A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0733EA8-70FA-C4ED-26B7-91AD36E11A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35765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ACED501-8E52-3BB3-545C-610CFEF3D3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0323B12-795C-7AAB-1112-43E45A45C70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CE1216E3-9908-391E-865B-F989192799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2E44A6C-F39B-712C-9900-F524A54FA8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F6692CD-E4D8-8B16-4B95-84F5E52FB9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5922F0C-8B14-D5BB-3F48-CDBC90983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59555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122EF17-40AA-89E7-2711-E29692AFF8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1FD33F8-580F-C397-D6FB-858AE4D971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4E6B1D3-942D-65BB-3738-4188B1C2F8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E3E124FC-F9D1-5575-A7E1-E97377EB09E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A2FE1A26-0BF5-70A4-FD63-47295E7466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1424F6B9-A8CE-A17C-CB0F-F996263B3D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1ACFE8D6-DAF6-2374-AB3F-5B24C53D5D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0A05C7E7-E8B4-1719-E868-82B1023F25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90102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6ABC102-7894-6AC2-7C63-0EBD89B009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3FB3E9FE-E869-E34C-4AFA-F1E8A6703F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7BDD2D1B-B63A-AA1D-33AE-46CD987372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5649DCD1-0261-3739-17DE-F930F221DD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58264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49D2A119-08F9-597A-AF12-E49F865FF5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B1100E02-7195-D142-C1B7-EC3AE26EA5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D9DC6580-A49A-7C80-57F8-EB2B8168F4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8107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D90B2A5-1D96-2BC2-334A-921DB6A827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9877CDE-9E5E-48FC-7688-4AA395405AF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FC66023-90E9-8086-202E-54CEAF8983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1FEC290-80C0-AFC8-E41D-BF8CF801CB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9A93779-A6C7-86E7-5895-AF5907B3EF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6666EA4-6B53-535C-D7C5-944887030F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0637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B5DCD79-C6C8-1057-AD1D-9ADA961BB8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50E513C4-F98E-C664-D4B5-7190E6F331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14F0017-29AB-364E-D52C-CC860F9AA1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4D43340-9E74-D37B-CE08-6211840D31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F54A728-964D-02DC-E11C-432C0CE3A2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7392E2B-7E61-D83C-A3B6-88D528E11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8479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D6A27737-528A-E1A6-EABC-C121FA7008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9743D47-1DBA-B9A3-9758-530041C60F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2000E22-A0E9-22FF-2A91-E0CCF5BA94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1C573E-BDE9-4291-91B4-E313959C2630}" type="datetimeFigureOut">
              <a:rPr lang="fr-FR" smtClean="0"/>
              <a:t>02/08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42C9074-BE9C-2FAD-68BD-F7FA71BC8E7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4D53F51-1FF8-FC20-8FB3-DA89E859B1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A9188A-5FFE-4E32-A117-4A56377B489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154659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E52C2A68-3EE9-1F27-D46F-3EFDE9080EA9}"/>
              </a:ext>
            </a:extLst>
          </p:cNvPr>
          <p:cNvSpPr txBox="1"/>
          <p:nvPr/>
        </p:nvSpPr>
        <p:spPr>
          <a:xfrm>
            <a:off x="6674524" y="1612124"/>
            <a:ext cx="4824000" cy="36337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l 4.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Biological replicate used for the quantification in Figure 2b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Well B contains non-floated PC:PE:NTA-Ni liposomes incubated with HR1-His peptides. Well G contains the corresponding floated sample. Wells C and D contain non-floated PC:MAL and PC:PE:MAL liposomes, both incubated with HR1-Cys peptides. Wells H and I contain the corresponding floated samples. The remaining wells contain other samples that are not relevant to the figures presented in the manuscript.</a:t>
            </a:r>
            <a:endParaRPr lang="fr-FR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8340" y="1187651"/>
            <a:ext cx="5844540" cy="4757867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1130968" y="4000835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1579348" y="4000835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2027728" y="4000835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2476108" y="4000834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2924488" y="4000834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3372868" y="4000833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3821248" y="4000833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4269628" y="4000833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4718008" y="4000833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5166388" y="4000832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J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B0AD380D-D437-8BAB-F94B-93FD2320F7F7}"/>
              </a:ext>
            </a:extLst>
          </p:cNvPr>
          <p:cNvSpPr txBox="1"/>
          <p:nvPr/>
        </p:nvSpPr>
        <p:spPr>
          <a:xfrm>
            <a:off x="5614767" y="4000832"/>
            <a:ext cx="425116" cy="355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fr-FR" sz="16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</a:t>
            </a:r>
            <a:endParaRPr lang="fr-FR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467758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1</TotalTime>
  <Words>98</Words>
  <Application>Microsoft Office PowerPoint</Application>
  <PresentationFormat>Grand écran</PresentationFormat>
  <Paragraphs>1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nais VLIEGHE</dc:creator>
  <cp:lastModifiedBy>David Tareste</cp:lastModifiedBy>
  <cp:revision>45</cp:revision>
  <dcterms:created xsi:type="dcterms:W3CDTF">2023-08-01T09:01:08Z</dcterms:created>
  <dcterms:modified xsi:type="dcterms:W3CDTF">2023-08-02T09:11:02Z</dcterms:modified>
</cp:coreProperties>
</file>